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2" r:id="rId7"/>
    <p:sldId id="263" r:id="rId8"/>
    <p:sldId id="264" r:id="rId9"/>
    <p:sldId id="265" r:id="rId10"/>
    <p:sldId id="266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/>
    <p:restoredTop sz="94694"/>
  </p:normalViewPr>
  <p:slideViewPr>
    <p:cSldViewPr snapToGrid="0">
      <p:cViewPr varScale="1">
        <p:scale>
          <a:sx n="109" d="100"/>
          <a:sy n="109" d="100"/>
        </p:scale>
        <p:origin x="6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9A4EA6-52A7-1154-3280-3EB8AEEED9D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163CF91-08A4-F27B-2318-FD1939C24C6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BF8C52-A745-C8EF-2915-DB3A7CD9BC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940D4-933E-4F4C-BE56-A76A17858538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B918EC-4F4A-64C0-4250-94AC349934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1BA8F3-334D-88A9-D1ED-C139697625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43577-10D1-D64E-B108-43AF05600B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845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12E60E-84CA-985C-C063-7CED95AE48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374931A-FB5C-211F-3EE7-408EF093FED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D5CF42-BD22-DBC0-669E-19AEC2BF8A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940D4-933E-4F4C-BE56-A76A17858538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FCA2E5-F7EA-30FC-BE17-3753F88F84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2E4DE5-D49D-E15D-0338-60CF0FE670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43577-10D1-D64E-B108-43AF05600B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94228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E12351D-30AD-922A-CFBC-F15AD33F6F0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3E312F4-2CC2-BFC1-9134-1B84985ACB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15C037-A177-3065-B0C3-ADFC4E8BB1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940D4-933E-4F4C-BE56-A76A17858538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9224F4-CB05-FE40-077C-90D22AA9AD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B3A2C4-11BE-71D2-CE29-5276B2D803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43577-10D1-D64E-B108-43AF05600B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39795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1882A9-DCE6-D4E0-313D-2CAC085840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7CDFBA-DAB2-AA2A-11E5-32A17CD404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2BA221-E6F8-4072-F329-A297F55ECE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940D4-933E-4F4C-BE56-A76A17858538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E413E6-2EDF-3D87-C5A0-BA7D33CE7C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910E39-ADB0-A228-2FA6-31C02F8556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43577-10D1-D64E-B108-43AF05600B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5736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B21D04-DE92-B2D0-E759-141B93E6A3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7D7ACA-FCE0-F9E1-EBBB-5C86D09192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666265-DD1A-FD2F-C0BE-7EFE2227E8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940D4-933E-4F4C-BE56-A76A17858538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222425-D01F-67D7-7FF8-1A7BE9ACF7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F35BA7-3B27-56BC-6CE8-CDE07BC412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43577-10D1-D64E-B108-43AF05600B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41088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E35823-4056-FD80-8F93-0CB12ECCBE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26EFA8-6340-8980-A602-5FA7CD1FB5E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A037C50-16C1-1B46-CC0B-EAA8961F16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38917B-522F-6FD6-34F1-59DC677971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940D4-933E-4F4C-BE56-A76A17858538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BD93D8-F506-57C4-368B-3468B0FF2B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4FC142B-6658-F701-0B7D-98C9ECC602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43577-10D1-D64E-B108-43AF05600B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96105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16E39B-532C-688B-F52B-0BEEB7AE2A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9E9012-B310-A90C-5A35-300A38E8B7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B4D532B-4312-BDA5-57EF-3889A57736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8B3348D-898D-4048-DCBA-09CA3E2BA9E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7D73A79-7895-D89E-AE38-5BA854180C1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6B42BE3-1598-DA03-F882-08E652552D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940D4-933E-4F4C-BE56-A76A17858538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9CC7007-0138-887A-B32B-87373E3506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989CE2A-4CD4-18AD-2D6E-1076A3DDF2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43577-10D1-D64E-B108-43AF05600B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57423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C0CBC7-2E74-9EE0-F7D5-479BD55602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2CDF5BE-EBAE-C3CA-1287-8CB0188CDE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940D4-933E-4F4C-BE56-A76A17858538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645F438-AB7E-2213-BF5A-904B1A3618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7F4728C-2EE7-F44A-ACDD-BE27A8A23D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43577-10D1-D64E-B108-43AF05600B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710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E0C49F2-B3DD-A44E-4E41-DD4BBC9024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940D4-933E-4F4C-BE56-A76A17858538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924D80B-89A1-2BD8-01D4-36E1688B24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FC1E384-A2E8-934E-ABA6-0B5FBBDE46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43577-10D1-D64E-B108-43AF05600B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7568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4BA045-1980-5217-0378-0B45EEC09B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F83B29-2228-DE04-6CB7-C4798C321D4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A07F8D3-9D19-27D5-B21E-1E0A31C8B2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CE5E80-E980-4FC6-53B7-8361D32E8A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940D4-933E-4F4C-BE56-A76A17858538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897E66-73AF-0155-9A60-353CD721E3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70B039-478A-6D2E-9300-EFE4E8F54E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43577-10D1-D64E-B108-43AF05600B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60805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91C0EE-84B7-F1D3-BFD7-7A2C6A6C91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882D40D-A01D-2D42-7839-3395064139A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24F4154-7602-6DF4-DB99-BA224225BC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3C0B944-04C8-C993-195B-00FD598CE8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940D4-933E-4F4C-BE56-A76A17858538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A1B60B8-25A5-A948-8F2B-4EECD67713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3B2FBB2-8354-9E66-730D-B43ABBACD6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43577-10D1-D64E-B108-43AF05600B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9965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AAEA161-35BA-F7A5-111D-8F2F9F33D5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CA29A0-8084-0A5E-7236-EFA8649DA9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FBCA63-1AEE-1F13-2339-A31F3B7EB9A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B940D4-933E-4F4C-BE56-A76A17858538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EDEDE7-C5DB-1DE4-4C06-CAEF18761C3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A1F2BE-BAEA-0B42-3DC7-17F14CA6A3E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B43577-10D1-D64E-B108-43AF05600B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71022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4F902CD-8484-4D7F-5FC8-684B84D4CD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8544" y="663122"/>
            <a:ext cx="5270500" cy="52705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11355" y="130629"/>
            <a:ext cx="88357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Normal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D67DD9B5-0056-431A-BD96-699157680201}"/>
              </a:ext>
            </a:extLst>
          </p:cNvPr>
          <p:cNvSpPr/>
          <p:nvPr/>
        </p:nvSpPr>
        <p:spPr>
          <a:xfrm>
            <a:off x="5992168" y="848558"/>
            <a:ext cx="6096000" cy="2031325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b="1" dirty="0"/>
              <a:t>Supplemental Figure 1:</a:t>
            </a:r>
          </a:p>
          <a:p>
            <a:r>
              <a:rPr lang="en-US" dirty="0"/>
              <a:t>5 Normal Cosine GMs Similarity Time-series signals</a:t>
            </a:r>
          </a:p>
          <a:p>
            <a:r>
              <a:rPr lang="en-US" dirty="0"/>
              <a:t>Legend: The x-axis represents the frame number and the y-axis represents the cosine similarity. A cosine similarity of 0 indicates perpendicular vectors, +1 indicates vectors with similar orientation and -1 indicates vectors in opposite direction.</a:t>
            </a:r>
          </a:p>
        </p:txBody>
      </p:sp>
    </p:spTree>
    <p:extLst>
      <p:ext uri="{BB962C8B-B14F-4D97-AF65-F5344CB8AC3E}">
        <p14:creationId xmlns:p14="http://schemas.microsoft.com/office/powerpoint/2010/main" val="379968006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240EFC2-CFD1-8BC9-E0F8-96574A56CA5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5780" y="976837"/>
            <a:ext cx="5245100" cy="52705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190813" y="257294"/>
            <a:ext cx="233544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ramped Synchronized</a:t>
            </a:r>
          </a:p>
        </p:txBody>
      </p:sp>
    </p:spTree>
    <p:extLst>
      <p:ext uri="{BB962C8B-B14F-4D97-AF65-F5344CB8AC3E}">
        <p14:creationId xmlns:p14="http://schemas.microsoft.com/office/powerpoint/2010/main" val="12295816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DE4272D2-C516-3FD4-3B94-D9358FD61E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9173" y="776332"/>
            <a:ext cx="5270500" cy="52705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385526" y="239877"/>
            <a:ext cx="88357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Normal</a:t>
            </a:r>
          </a:p>
        </p:txBody>
      </p:sp>
    </p:spTree>
    <p:extLst>
      <p:ext uri="{BB962C8B-B14F-4D97-AF65-F5344CB8AC3E}">
        <p14:creationId xmlns:p14="http://schemas.microsoft.com/office/powerpoint/2010/main" val="37489338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F975DD3-BD18-7C3A-1BFB-8600C12486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6590" y="732790"/>
            <a:ext cx="5270500" cy="52705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420361" y="156031"/>
            <a:ext cx="88357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Normal</a:t>
            </a:r>
          </a:p>
        </p:txBody>
      </p:sp>
    </p:spTree>
    <p:extLst>
      <p:ext uri="{BB962C8B-B14F-4D97-AF65-F5344CB8AC3E}">
        <p14:creationId xmlns:p14="http://schemas.microsoft.com/office/powerpoint/2010/main" val="27615295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10F9628-5E63-1BE2-95CE-4EBDD8B3172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3710" y="898253"/>
            <a:ext cx="5270500" cy="52705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473710" y="309546"/>
            <a:ext cx="88357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Normal</a:t>
            </a:r>
          </a:p>
        </p:txBody>
      </p:sp>
    </p:spTree>
    <p:extLst>
      <p:ext uri="{BB962C8B-B14F-4D97-AF65-F5344CB8AC3E}">
        <p14:creationId xmlns:p14="http://schemas.microsoft.com/office/powerpoint/2010/main" val="34883499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AF0C7EB-FF2B-D626-BEA5-30AA818598B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5333" y="750208"/>
            <a:ext cx="5270500" cy="52705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395333" y="274711"/>
            <a:ext cx="88357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Normal</a:t>
            </a:r>
          </a:p>
        </p:txBody>
      </p:sp>
    </p:spTree>
    <p:extLst>
      <p:ext uri="{BB962C8B-B14F-4D97-AF65-F5344CB8AC3E}">
        <p14:creationId xmlns:p14="http://schemas.microsoft.com/office/powerpoint/2010/main" val="837604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C072D5F-D339-31C3-F0B1-0BD6704B9BE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1790" y="1081340"/>
            <a:ext cx="5270500" cy="52705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09005" y="319916"/>
            <a:ext cx="233544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ramped Synchronized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609A5DB-4D0B-48AC-8F14-89A234627005}"/>
              </a:ext>
            </a:extLst>
          </p:cNvPr>
          <p:cNvSpPr txBox="1"/>
          <p:nvPr/>
        </p:nvSpPr>
        <p:spPr>
          <a:xfrm>
            <a:off x="5927384" y="2413337"/>
            <a:ext cx="6097464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l Figure 1</a:t>
            </a:r>
            <a:r>
              <a:rPr lang="en-US" dirty="0"/>
              <a:t>: 5 Cramped Synchronized GMs Cosine Similarity Time-series signals.</a:t>
            </a:r>
          </a:p>
          <a:p>
            <a:r>
              <a:rPr lang="en-US" dirty="0"/>
              <a:t>Legend: The x-axis represents the frame number </a:t>
            </a:r>
          </a:p>
          <a:p>
            <a:r>
              <a:rPr lang="en-US" dirty="0"/>
              <a:t>and the y-axis represents the cosine similarity.</a:t>
            </a:r>
          </a:p>
          <a:p>
            <a:r>
              <a:rPr lang="en-US" dirty="0"/>
              <a:t>A cosine similarity of 0 indicates perpendicular vectors, +1 indicates vectors with similar orientation and -1 indicates vectors in opposite direction.</a:t>
            </a:r>
          </a:p>
        </p:txBody>
      </p:sp>
    </p:spTree>
    <p:extLst>
      <p:ext uri="{BB962C8B-B14F-4D97-AF65-F5344CB8AC3E}">
        <p14:creationId xmlns:p14="http://schemas.microsoft.com/office/powerpoint/2010/main" val="403108611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A6B4149-555F-EE63-BFCC-AEBC42D2DF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2867" y="706664"/>
            <a:ext cx="5245100" cy="52705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08230" y="178917"/>
            <a:ext cx="233544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ramped Synchronized</a:t>
            </a:r>
          </a:p>
        </p:txBody>
      </p:sp>
    </p:spTree>
    <p:extLst>
      <p:ext uri="{BB962C8B-B14F-4D97-AF65-F5344CB8AC3E}">
        <p14:creationId xmlns:p14="http://schemas.microsoft.com/office/powerpoint/2010/main" val="192243522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C5705D2-BB21-FA7E-FC85-87AB762C5F7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1459" y="750207"/>
            <a:ext cx="5270500" cy="52705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43064" y="248586"/>
            <a:ext cx="233544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ramped Synchronized</a:t>
            </a:r>
          </a:p>
        </p:txBody>
      </p:sp>
    </p:spTree>
    <p:extLst>
      <p:ext uri="{BB962C8B-B14F-4D97-AF65-F5344CB8AC3E}">
        <p14:creationId xmlns:p14="http://schemas.microsoft.com/office/powerpoint/2010/main" val="47374030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6613CA6-E37F-798E-8E1C-FEA93455F29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6922" y="976838"/>
            <a:ext cx="5270500" cy="52705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286608" y="283419"/>
            <a:ext cx="233544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Cramped Synchronized</a:t>
            </a:r>
          </a:p>
        </p:txBody>
      </p:sp>
    </p:spTree>
    <p:extLst>
      <p:ext uri="{BB962C8B-B14F-4D97-AF65-F5344CB8AC3E}">
        <p14:creationId xmlns:p14="http://schemas.microsoft.com/office/powerpoint/2010/main" val="30428513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0</TotalTime>
  <Words>121</Words>
  <Application>Microsoft Office PowerPoint</Application>
  <PresentationFormat>Widescreen</PresentationFormat>
  <Paragraphs>17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Normal</dc:title>
  <dc:creator>Vince Pulido</dc:creator>
  <cp:lastModifiedBy>Letzkus, Lisa C *HS</cp:lastModifiedBy>
  <cp:revision>4</cp:revision>
  <dcterms:created xsi:type="dcterms:W3CDTF">2023-12-27T14:43:45Z</dcterms:created>
  <dcterms:modified xsi:type="dcterms:W3CDTF">2024-01-03T16:41:59Z</dcterms:modified>
</cp:coreProperties>
</file>